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3066" y="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mpus\home\home41\nmjb14\Manuscripts\HDAC6%20MMP\Copy%20of%20SW1353%2002-07-09%20siRNA%20HDACs%20KO%20Qiagen%20%20COMBIN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75487358951923"/>
          <c:y val="0.18771396851677158"/>
          <c:w val="0.79472720360579663"/>
          <c:h val="0.60799382571160809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3!$G$3:$G$13</c:f>
                <c:numCache>
                  <c:formatCode>General</c:formatCode>
                  <c:ptCount val="11"/>
                  <c:pt idx="0">
                    <c:v>1.7062115883211231</c:v>
                  </c:pt>
                  <c:pt idx="1">
                    <c:v>1.7771705705867806</c:v>
                  </c:pt>
                  <c:pt idx="2">
                    <c:v>7.3989331728618257</c:v>
                  </c:pt>
                  <c:pt idx="3">
                    <c:v>20.084879250904315</c:v>
                  </c:pt>
                  <c:pt idx="4">
                    <c:v>5.2955927539160452</c:v>
                  </c:pt>
                  <c:pt idx="5">
                    <c:v>5.6167625829693248</c:v>
                  </c:pt>
                  <c:pt idx="6">
                    <c:v>2.6704727904574543</c:v>
                  </c:pt>
                  <c:pt idx="7">
                    <c:v>1.7205011610961174</c:v>
                  </c:pt>
                  <c:pt idx="8">
                    <c:v>16.276166952963074</c:v>
                  </c:pt>
                  <c:pt idx="9">
                    <c:v>9.5963610465310758</c:v>
                  </c:pt>
                  <c:pt idx="10">
                    <c:v>14.157757857280377</c:v>
                  </c:pt>
                </c:numCache>
              </c:numRef>
            </c:plus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3!$B$3:$B$13</c:f>
              <c:strCache>
                <c:ptCount val="11"/>
                <c:pt idx="0">
                  <c:v>siHDAC1</c:v>
                </c:pt>
                <c:pt idx="1">
                  <c:v>siHDAC2</c:v>
                </c:pt>
                <c:pt idx="2">
                  <c:v>siHDAC3</c:v>
                </c:pt>
                <c:pt idx="3">
                  <c:v>siHDAC8</c:v>
                </c:pt>
                <c:pt idx="4">
                  <c:v>siHDAC4</c:v>
                </c:pt>
                <c:pt idx="5">
                  <c:v>siHDAC5</c:v>
                </c:pt>
                <c:pt idx="6">
                  <c:v>siHDAC6</c:v>
                </c:pt>
                <c:pt idx="7">
                  <c:v>siHDAC7</c:v>
                </c:pt>
                <c:pt idx="8">
                  <c:v>siHDAC9</c:v>
                </c:pt>
                <c:pt idx="9">
                  <c:v>siHDAC10</c:v>
                </c:pt>
                <c:pt idx="10">
                  <c:v>siHDAC11</c:v>
                </c:pt>
              </c:strCache>
            </c:strRef>
          </c:cat>
          <c:val>
            <c:numRef>
              <c:f>Sheet3!$F$3:$F$13</c:f>
              <c:numCache>
                <c:formatCode>General</c:formatCode>
                <c:ptCount val="11"/>
                <c:pt idx="0">
                  <c:v>15.104317824241967</c:v>
                </c:pt>
                <c:pt idx="1">
                  <c:v>8.9092262672893732</c:v>
                </c:pt>
                <c:pt idx="2">
                  <c:v>27.087222544928906</c:v>
                </c:pt>
                <c:pt idx="3">
                  <c:v>51.638552458745885</c:v>
                </c:pt>
                <c:pt idx="4">
                  <c:v>51.491555085293783</c:v>
                </c:pt>
                <c:pt idx="5">
                  <c:v>28.785685237261482</c:v>
                </c:pt>
                <c:pt idx="6">
                  <c:v>6.7545024681091963</c:v>
                </c:pt>
                <c:pt idx="7">
                  <c:v>33.251579870145797</c:v>
                </c:pt>
                <c:pt idx="8">
                  <c:v>55.424589896430575</c:v>
                </c:pt>
                <c:pt idx="9">
                  <c:v>40.580539154174581</c:v>
                </c:pt>
                <c:pt idx="10">
                  <c:v>39.5961486673270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78-4A3A-810B-5E51D0FCD2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46407944"/>
        <c:axId val="1"/>
      </c:barChart>
      <c:catAx>
        <c:axId val="546407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270000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Gene</a:t>
                </a:r>
                <a:r>
                  <a:rPr lang="en-GB" baseline="0"/>
                  <a:t> / 18S (% vs Con siRNA)</a:t>
                </a:r>
                <a:endParaRPr lang="en-GB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64079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7458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977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7119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0783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788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5040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5495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2616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4292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0607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5059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619D5-A03A-4749-88E4-363B196FEB9B}" type="datetimeFigureOut">
              <a:rPr lang="en-GB" smtClean="0"/>
              <a:t>03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D4A30-D375-437F-B0DC-46C1E5E9C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905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542925" y="614362"/>
          <a:ext cx="4762500" cy="3895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273050" y="4600947"/>
            <a:ext cx="6280150" cy="9529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000" b="1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upplementary Figure 1. HDAC knockdown efficiency</a:t>
            </a:r>
            <a:endParaRPr lang="en-GB" sz="1000" kern="150" dirty="0">
              <a:latin typeface="Calibri" panose="020F0502020204030204" pitchFamily="34" charset="0"/>
              <a:ea typeface="SimSun" panose="02010600030101010101" pitchFamily="2" charset="-122"/>
              <a:cs typeface="Mangal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W1353 cells were transfected with the indicated HDAC-</a:t>
            </a:r>
            <a:r>
              <a:rPr lang="en-GB" sz="1000" kern="150" dirty="0" err="1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argetting</a:t>
            </a: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siRNAs for 24 hours prior to stimulation with IL-1 for 8 hours. </a:t>
            </a: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Mangal"/>
              </a:rPr>
              <a:t>Data are presented as % knockdown compared to non-</a:t>
            </a:r>
            <a:r>
              <a:rPr lang="en-GB" sz="1000" kern="150" dirty="0" err="1">
                <a:latin typeface="Calibri" panose="020F0502020204030204" pitchFamily="34" charset="0"/>
                <a:ea typeface="SimSun" panose="02010600030101010101" pitchFamily="2" charset="-122"/>
                <a:cs typeface="Mangal"/>
              </a:rPr>
              <a:t>targetting</a:t>
            </a: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Mangal"/>
              </a:rPr>
              <a:t> control siRNA and represent mean ± S.D. Data are representative of a minimum of three independent experiments</a:t>
            </a: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performed in quadruplicate</a:t>
            </a:r>
            <a:r>
              <a:rPr lang="en-GB" sz="1000" kern="150" dirty="0">
                <a:latin typeface="Calibri" panose="020F0502020204030204" pitchFamily="34" charset="0"/>
                <a:ea typeface="SimSun" panose="02010600030101010101" pitchFamily="2" charset="-122"/>
                <a:cs typeface="Mangal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70057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7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Mangal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 Barter</dc:creator>
  <cp:lastModifiedBy>Matt Barter</cp:lastModifiedBy>
  <cp:revision>2</cp:revision>
  <dcterms:created xsi:type="dcterms:W3CDTF">2021-10-13T14:59:14Z</dcterms:created>
  <dcterms:modified xsi:type="dcterms:W3CDTF">2021-11-03T10:41:31Z</dcterms:modified>
</cp:coreProperties>
</file>